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C78918-D46C-4BD5-8D1F-CA503B7F4DA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48" b="9755"/>
          <a:stretch>
            <a:fillRect/>
          </a:stretch>
        </p:blipFill>
        <p:spPr>
          <a:xfrm>
            <a:off x="6246926" y="-16401"/>
            <a:ext cx="3264022" cy="308499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20" b="9201"/>
          <a:stretch>
            <a:fillRect/>
          </a:stretch>
        </p:blipFill>
        <p:spPr>
          <a:xfrm>
            <a:off x="0" y="-16401"/>
            <a:ext cx="3116156" cy="316575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563" b="8924"/>
          <a:stretch>
            <a:fillRect/>
          </a:stretch>
        </p:blipFill>
        <p:spPr>
          <a:xfrm>
            <a:off x="3116156" y="64364"/>
            <a:ext cx="3121405" cy="308499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90" b="5686"/>
          <a:stretch>
            <a:fillRect/>
          </a:stretch>
        </p:blipFill>
        <p:spPr>
          <a:xfrm>
            <a:off x="0" y="3068589"/>
            <a:ext cx="3116156" cy="326556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93" b="8170"/>
          <a:stretch>
            <a:fillRect/>
          </a:stretch>
        </p:blipFill>
        <p:spPr>
          <a:xfrm>
            <a:off x="3101880" y="3149353"/>
            <a:ext cx="3135682" cy="3084989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11" b="8647"/>
          <a:stretch>
            <a:fillRect/>
          </a:stretch>
        </p:blipFill>
        <p:spPr>
          <a:xfrm>
            <a:off x="6226914" y="3232293"/>
            <a:ext cx="3264022" cy="3002049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35260" y="154517"/>
            <a:ext cx="359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391364" y="154517"/>
            <a:ext cx="319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513256" y="154517"/>
            <a:ext cx="328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21571" y="3244334"/>
            <a:ext cx="372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391364" y="3244334"/>
            <a:ext cx="319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512770" y="3244334"/>
            <a:ext cx="337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44104" y="6147305"/>
            <a:ext cx="1184789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. 1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unnel plot of publication bias included in this Meta-analysis. A: 3-year OS; B: 5-year OS; C: 3-year RFS; D:5-year RFS; E: Local recurrence; F: Complication. </a:t>
            </a:r>
            <a:endParaRPr lang="zh-CN" altLang="en-US" dirty="0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WY4M2FlMGNhMmIxYTI5MTRjYTQ2NTE5NGI5OTgyODE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5</Words>
  <Application>WPS 演示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Arial Unicode MS</vt:lpstr>
      <vt:lpstr>Calibri</vt:lpstr>
      <vt:lpstr>微软雅黑</vt:lpstr>
      <vt:lpstr>Times New Roman</vt:lpstr>
      <vt:lpstr>等线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ei liu</dc:creator>
  <cp:lastModifiedBy>Mr.</cp:lastModifiedBy>
  <cp:revision>2</cp:revision>
  <dcterms:created xsi:type="dcterms:W3CDTF">2023-07-06T14:28:00Z</dcterms:created>
  <dcterms:modified xsi:type="dcterms:W3CDTF">2023-07-06T14:28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D7104FDFA5946D495FD3010E55F6FF1_12</vt:lpwstr>
  </property>
  <property fmtid="{D5CDD505-2E9C-101B-9397-08002B2CF9AE}" pid="3" name="KSOProductBuildVer">
    <vt:lpwstr>2052-11.1.0.14036</vt:lpwstr>
  </property>
</Properties>
</file>